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906000" cy="6858000" type="A4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-2520" y="-120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B13323-12B6-4944-B1A4-91DA530246BB}" type="datetimeFigureOut">
              <a:rPr lang="en-US" smtClean="0"/>
              <a:t>10/07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8050" y="698500"/>
            <a:ext cx="5041900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085"/>
            <a:ext cx="5486400" cy="41912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553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46553"/>
            <a:ext cx="2971800" cy="46569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3CFC45-09D1-4C67-ADDD-BE999966A8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6547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3CFC45-09D1-4C67-ADDD-BE999966A83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2067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065AEC-CF7F-4400-9B14-D10A86FDC796}" type="datetimeFigureOut">
              <a:rPr lang="en-GB" smtClean="0"/>
              <a:pPr/>
              <a:t>1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A83E9-4072-4351-BB23-F42A5E8617DA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9171" y="-34912"/>
            <a:ext cx="10142918" cy="6899426"/>
            <a:chOff x="19171" y="-34912"/>
            <a:chExt cx="10142918" cy="6899426"/>
          </a:xfrm>
        </p:grpSpPr>
        <p:grpSp>
          <p:nvGrpSpPr>
            <p:cNvPr id="4" name="Group 3"/>
            <p:cNvGrpSpPr/>
            <p:nvPr/>
          </p:nvGrpSpPr>
          <p:grpSpPr>
            <a:xfrm>
              <a:off x="6506752" y="-34912"/>
              <a:ext cx="3655337" cy="6870199"/>
              <a:chOff x="6492897" y="-34912"/>
              <a:chExt cx="3655337" cy="6870199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 rotWithShape="1">
              <a:blip r:embed="rId3" cstate="print"/>
              <a:srcRect l="49163" t="52725" r="16666"/>
              <a:stretch/>
            </p:blipFill>
            <p:spPr bwMode="auto">
              <a:xfrm>
                <a:off x="6835180" y="3523565"/>
                <a:ext cx="2378670" cy="151893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7490610" y="-34912"/>
                <a:ext cx="122829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 smtClean="0">
                    <a:latin typeface="Arial" pitchFamily="34" charset="0"/>
                    <a:cs typeface="Arial" pitchFamily="34" charset="0"/>
                  </a:rPr>
                  <a:t>GNMT</a:t>
                </a:r>
                <a:endParaRPr lang="en-GB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9169385" y="2522996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4.E</a:t>
                </a:r>
                <a:endParaRPr lang="en-GB" sz="900" dirty="0" smtClean="0"/>
              </a:p>
              <a:p>
                <a:r>
                  <a:rPr lang="en-GB" sz="900" dirty="0" smtClean="0"/>
                  <a:t>MI = 26.8%</a:t>
                </a:r>
                <a:endParaRPr lang="en-GB" sz="900" dirty="0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6508750" y="3316142"/>
                <a:ext cx="3639484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s =0.46/0.50/0.41/0.51/0.50/0.49/0.49/0.38/0.40/0.33/0.39 </a:t>
                </a:r>
                <a:endParaRPr lang="en-GB" sz="8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9157466" y="4199920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6.L</a:t>
                </a:r>
                <a:endParaRPr lang="en-GB" sz="900" dirty="0" smtClean="0"/>
              </a:p>
              <a:p>
                <a:r>
                  <a:rPr lang="en-GB" sz="900" dirty="0" smtClean="0"/>
                  <a:t>MI = 3.2%</a:t>
                </a:r>
                <a:endParaRPr lang="en-GB" sz="900" dirty="0"/>
              </a:p>
            </p:txBody>
          </p:sp>
          <p:pic>
            <p:nvPicPr>
              <p:cNvPr id="26" name="Picture 4"/>
              <p:cNvPicPr>
                <a:picLocks noChangeAspect="1" noChangeArrowheads="1"/>
              </p:cNvPicPr>
              <p:nvPr/>
            </p:nvPicPr>
            <p:blipFill rotWithShape="1">
              <a:blip r:embed="rId3" cstate="print"/>
              <a:srcRect r="66897" b="51947"/>
              <a:stretch/>
            </p:blipFill>
            <p:spPr bwMode="auto">
              <a:xfrm>
                <a:off x="6919079" y="346173"/>
                <a:ext cx="2294771" cy="15439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7" name="TextBox 26"/>
              <p:cNvSpPr txBox="1"/>
              <p:nvPr/>
            </p:nvSpPr>
            <p:spPr>
              <a:xfrm>
                <a:off x="9174024" y="896730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1.L</a:t>
                </a:r>
                <a:endParaRPr lang="en-GB" sz="900" dirty="0" smtClean="0"/>
              </a:p>
              <a:p>
                <a:r>
                  <a:rPr lang="en-GB" sz="900" dirty="0" smtClean="0"/>
                  <a:t>MI = 94.6%</a:t>
                </a:r>
                <a:endParaRPr lang="en-GB" sz="9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9175826" y="5915940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9.E</a:t>
                </a:r>
                <a:endParaRPr lang="en-GB" sz="900" dirty="0" smtClean="0"/>
              </a:p>
              <a:p>
                <a:r>
                  <a:rPr lang="en-GB" sz="900" dirty="0" smtClean="0"/>
                  <a:t>MI = 3.9%</a:t>
                </a:r>
                <a:endParaRPr lang="en-GB" sz="900" dirty="0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6504948" y="4937160"/>
                <a:ext cx="3486777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 = 0.15/0.08/0.12/0.16/0.14/0.07/0.09/0.18/0.16/0.05/0.16</a:t>
                </a:r>
                <a:endParaRPr lang="en-GB" sz="800" dirty="0"/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6492897" y="6619843"/>
                <a:ext cx="3464837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s = 0.18/0.09/0.15/0.08/0.10/0.12/0.07/0.12/0.06/0.03/0.11</a:t>
                </a:r>
                <a:endParaRPr lang="en-GB" sz="800" dirty="0"/>
              </a:p>
            </p:txBody>
          </p:sp>
          <p:pic>
            <p:nvPicPr>
              <p:cNvPr id="57" name="Picture 4"/>
              <p:cNvPicPr>
                <a:picLocks noChangeAspect="1" noChangeArrowheads="1"/>
              </p:cNvPicPr>
              <p:nvPr/>
            </p:nvPicPr>
            <p:blipFill rotWithShape="1">
              <a:blip r:embed="rId3" cstate="print"/>
              <a:srcRect t="54193" r="66897"/>
              <a:stretch/>
            </p:blipFill>
            <p:spPr bwMode="auto">
              <a:xfrm>
                <a:off x="6880431" y="5157373"/>
                <a:ext cx="2333419" cy="1471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58" name="Picture 4"/>
              <p:cNvPicPr>
                <a:picLocks noChangeAspect="1" noChangeArrowheads="1"/>
              </p:cNvPicPr>
              <p:nvPr/>
            </p:nvPicPr>
            <p:blipFill rotWithShape="1">
              <a:blip r:embed="rId3" cstate="print"/>
              <a:srcRect l="49163" r="16666" b="56629"/>
              <a:stretch/>
            </p:blipFill>
            <p:spPr bwMode="auto">
              <a:xfrm>
                <a:off x="6847880" y="1980335"/>
                <a:ext cx="2365970" cy="13935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2" name="Group 1"/>
            <p:cNvGrpSpPr/>
            <p:nvPr/>
          </p:nvGrpSpPr>
          <p:grpSpPr>
            <a:xfrm>
              <a:off x="19171" y="0"/>
              <a:ext cx="3221421" cy="6864514"/>
              <a:chOff x="19171" y="0"/>
              <a:chExt cx="3221421" cy="6864514"/>
            </a:xfrm>
          </p:grpSpPr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 rotWithShape="1">
              <a:blip r:embed="rId4" cstate="print"/>
              <a:srcRect t="56996" r="66836"/>
              <a:stretch/>
            </p:blipFill>
            <p:spPr bwMode="auto">
              <a:xfrm>
                <a:off x="172939" y="5214151"/>
                <a:ext cx="2292011" cy="14581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742266" y="0"/>
                <a:ext cx="122829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 smtClean="0">
                    <a:latin typeface="Arial" pitchFamily="34" charset="0"/>
                    <a:cs typeface="Arial" pitchFamily="34" charset="0"/>
                  </a:rPr>
                  <a:t>ALS2CL</a:t>
                </a:r>
                <a:endParaRPr lang="en-GB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392117" y="2684986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6.E</a:t>
                </a:r>
                <a:endParaRPr lang="en-GB" sz="900" dirty="0" smtClean="0"/>
              </a:p>
              <a:p>
                <a:r>
                  <a:rPr lang="en-GB" sz="900" dirty="0" smtClean="0"/>
                  <a:t>MI = 33.3%</a:t>
                </a:r>
                <a:endParaRPr lang="en-GB" sz="900" dirty="0"/>
              </a:p>
            </p:txBody>
          </p:sp>
          <p:pic>
            <p:nvPicPr>
              <p:cNvPr id="36" name="Picture 3"/>
              <p:cNvPicPr>
                <a:picLocks noChangeAspect="1" noChangeArrowheads="1"/>
              </p:cNvPicPr>
              <p:nvPr/>
            </p:nvPicPr>
            <p:blipFill rotWithShape="1">
              <a:blip r:embed="rId4" cstate="print"/>
              <a:srcRect l="48070" t="54950" r="16836"/>
              <a:stretch/>
            </p:blipFill>
            <p:spPr bwMode="auto">
              <a:xfrm>
                <a:off x="19171" y="3523852"/>
                <a:ext cx="2425410" cy="15275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2360367" y="4264651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9.L</a:t>
                </a:r>
                <a:endParaRPr lang="en-GB" sz="900" dirty="0" smtClean="0"/>
              </a:p>
              <a:p>
                <a:r>
                  <a:rPr lang="en-GB" sz="900" dirty="0" smtClean="0"/>
                  <a:t>MI = 12%</a:t>
                </a:r>
                <a:endParaRPr lang="en-GB" sz="9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2449022" y="941796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1.E</a:t>
                </a:r>
                <a:endParaRPr lang="en-GB" sz="900" dirty="0" smtClean="0"/>
              </a:p>
              <a:p>
                <a:r>
                  <a:rPr lang="en-GB" sz="900" dirty="0" smtClean="0"/>
                  <a:t>MI = 21%</a:t>
                </a:r>
                <a:endParaRPr lang="en-GB" sz="9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376441" y="5915195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9.E</a:t>
                </a:r>
                <a:endParaRPr lang="en-GB" sz="900" dirty="0" smtClean="0"/>
              </a:p>
              <a:p>
                <a:r>
                  <a:rPr lang="en-GB" sz="900" dirty="0" smtClean="0"/>
                  <a:t>MI = 11.1%</a:t>
                </a:r>
                <a:endParaRPr lang="en-GB" sz="900" dirty="0"/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707841" y="1834721"/>
                <a:ext cx="1274708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s = 0.75/0.77/0.81 </a:t>
                </a:r>
                <a:endParaRPr lang="en-GB" sz="800" dirty="0"/>
              </a:p>
            </p:txBody>
          </p:sp>
          <p:sp>
            <p:nvSpPr>
              <p:cNvPr id="41" name="Rectangle 40"/>
              <p:cNvSpPr/>
              <p:nvPr/>
            </p:nvSpPr>
            <p:spPr>
              <a:xfrm>
                <a:off x="633650" y="3253421"/>
                <a:ext cx="125226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s = 0.50/0.51/0.55</a:t>
                </a:r>
                <a:endParaRPr lang="en-GB" sz="800" dirty="0"/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750237" y="6649070"/>
                <a:ext cx="125226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s = 0.06/0.09/0.05</a:t>
                </a:r>
                <a:endParaRPr lang="en-GB" sz="800" dirty="0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741600" y="5009289"/>
                <a:ext cx="125226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s = 0.05/0.09/0.06</a:t>
                </a:r>
                <a:endParaRPr lang="en-GB" sz="800" dirty="0"/>
              </a:p>
            </p:txBody>
          </p:sp>
          <p:pic>
            <p:nvPicPr>
              <p:cNvPr id="53" name="Picture 3"/>
              <p:cNvPicPr>
                <a:picLocks noChangeAspect="1" noChangeArrowheads="1"/>
              </p:cNvPicPr>
              <p:nvPr/>
            </p:nvPicPr>
            <p:blipFill rotWithShape="1">
              <a:blip r:embed="rId4" cstate="print"/>
              <a:srcRect r="66836" b="54660"/>
              <a:stretch/>
            </p:blipFill>
            <p:spPr bwMode="auto">
              <a:xfrm>
                <a:off x="181997" y="321189"/>
                <a:ext cx="2292011" cy="153734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54" name="Picture 3"/>
              <p:cNvPicPr>
                <a:picLocks noChangeAspect="1" noChangeArrowheads="1"/>
              </p:cNvPicPr>
              <p:nvPr/>
            </p:nvPicPr>
            <p:blipFill rotWithShape="1">
              <a:blip r:embed="rId4" cstate="print"/>
              <a:srcRect l="48070" r="16836" b="57324"/>
              <a:stretch/>
            </p:blipFill>
            <p:spPr bwMode="auto">
              <a:xfrm>
                <a:off x="47078" y="2060419"/>
                <a:ext cx="2425409" cy="144702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59" name="Rectangle 58"/>
              <p:cNvSpPr/>
              <p:nvPr/>
            </p:nvSpPr>
            <p:spPr>
              <a:xfrm>
                <a:off x="741600" y="3415439"/>
                <a:ext cx="1252266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s = 0.09/0.14/0.07</a:t>
                </a:r>
                <a:endParaRPr lang="en-GB" sz="800" dirty="0"/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3101860" y="-23159"/>
              <a:ext cx="3378697" cy="6858722"/>
              <a:chOff x="3212700" y="-23159"/>
              <a:chExt cx="3378697" cy="6858722"/>
            </a:xfrm>
          </p:grpSpPr>
          <p:pic>
            <p:nvPicPr>
              <p:cNvPr id="56" name="Picture 5"/>
              <p:cNvPicPr>
                <a:picLocks noChangeAspect="1" noChangeArrowheads="1"/>
              </p:cNvPicPr>
              <p:nvPr/>
            </p:nvPicPr>
            <p:blipFill rotWithShape="1">
              <a:blip r:embed="rId5" cstate="print"/>
              <a:srcRect l="47266" r="17258" b="53416"/>
              <a:stretch/>
            </p:blipFill>
            <p:spPr bwMode="auto">
              <a:xfrm>
                <a:off x="3220834" y="1862608"/>
                <a:ext cx="2621531" cy="16509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29" name="Picture 5"/>
              <p:cNvPicPr>
                <a:picLocks noChangeAspect="1" noChangeArrowheads="1"/>
              </p:cNvPicPr>
              <p:nvPr/>
            </p:nvPicPr>
            <p:blipFill rotWithShape="1">
              <a:blip r:embed="rId5" cstate="print"/>
              <a:srcRect l="47266" t="53613" r="17258"/>
              <a:stretch/>
            </p:blipFill>
            <p:spPr bwMode="auto">
              <a:xfrm>
                <a:off x="3212700" y="3396154"/>
                <a:ext cx="2621532" cy="16438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4" name="TextBox 43"/>
              <p:cNvSpPr txBox="1"/>
              <p:nvPr/>
            </p:nvSpPr>
            <p:spPr>
              <a:xfrm>
                <a:off x="5789202" y="2662949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5.E</a:t>
                </a:r>
                <a:endParaRPr lang="en-GB" sz="900" dirty="0" smtClean="0"/>
              </a:p>
              <a:p>
                <a:r>
                  <a:rPr lang="en-GB" sz="900" dirty="0" smtClean="0"/>
                  <a:t>MI = 84.9%</a:t>
                </a:r>
                <a:endParaRPr lang="en-GB" sz="900" dirty="0"/>
              </a:p>
            </p:txBody>
          </p:sp>
          <p:pic>
            <p:nvPicPr>
              <p:cNvPr id="45" name="Picture 5"/>
              <p:cNvPicPr>
                <a:picLocks noChangeAspect="1" noChangeArrowheads="1"/>
              </p:cNvPicPr>
              <p:nvPr/>
            </p:nvPicPr>
            <p:blipFill rotWithShape="1">
              <a:blip r:embed="rId5" cstate="print"/>
              <a:srcRect t="55931" r="67674"/>
              <a:stretch/>
            </p:blipFill>
            <p:spPr bwMode="auto">
              <a:xfrm>
                <a:off x="3431046" y="5128865"/>
                <a:ext cx="2388793" cy="156177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6" name="TextBox 45"/>
              <p:cNvSpPr txBox="1"/>
              <p:nvPr/>
            </p:nvSpPr>
            <p:spPr>
              <a:xfrm>
                <a:off x="5795894" y="4184893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9.E</a:t>
                </a:r>
                <a:endParaRPr lang="en-GB" sz="900" dirty="0" smtClean="0"/>
              </a:p>
              <a:p>
                <a:r>
                  <a:rPr lang="en-GB" sz="900" dirty="0" smtClean="0"/>
                  <a:t>MI = 6.43%</a:t>
                </a:r>
                <a:endParaRPr lang="en-GB" sz="9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5772688" y="5916987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6.L</a:t>
                </a:r>
                <a:endParaRPr lang="en-GB" sz="900" dirty="0" smtClean="0"/>
              </a:p>
              <a:p>
                <a:r>
                  <a:rPr lang="en-GB" sz="900" dirty="0" smtClean="0"/>
                  <a:t>MI = 1.97%</a:t>
                </a:r>
                <a:endParaRPr lang="en-GB" sz="900" dirty="0"/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4220787" y="1773759"/>
                <a:ext cx="859807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 = 0.52</a:t>
                </a:r>
                <a:endParaRPr lang="en-GB" sz="800" dirty="0"/>
              </a:p>
            </p:txBody>
          </p:sp>
          <p:sp>
            <p:nvSpPr>
              <p:cNvPr id="50" name="Rectangle 49"/>
              <p:cNvSpPr/>
              <p:nvPr/>
            </p:nvSpPr>
            <p:spPr>
              <a:xfrm>
                <a:off x="4186909" y="6620119"/>
                <a:ext cx="77296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l-GR" sz="800" dirty="0" smtClean="0"/>
                  <a:t>β</a:t>
                </a:r>
                <a:r>
                  <a:rPr lang="en-GB" sz="800" dirty="0" smtClean="0"/>
                  <a:t>-value = 0.02</a:t>
                </a:r>
                <a:endParaRPr lang="en-GB" sz="800" dirty="0"/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4186909" y="5022790"/>
                <a:ext cx="10938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800" dirty="0"/>
                  <a:t>β</a:t>
                </a:r>
                <a:r>
                  <a:rPr lang="en-GB" sz="800" dirty="0" smtClean="0"/>
                  <a:t>-value = 0.03</a:t>
                </a:r>
                <a:endParaRPr lang="en-GB" sz="800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4182768" y="3316142"/>
                <a:ext cx="140042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800" dirty="0"/>
                  <a:t>β</a:t>
                </a:r>
                <a:r>
                  <a:rPr lang="en-GB" sz="800" dirty="0" smtClean="0"/>
                  <a:t>-value = 0.79</a:t>
                </a:r>
                <a:endParaRPr lang="en-GB" sz="800" dirty="0"/>
              </a:p>
            </p:txBody>
          </p:sp>
          <p:pic>
            <p:nvPicPr>
              <p:cNvPr id="55" name="Picture 5"/>
              <p:cNvPicPr>
                <a:picLocks noChangeAspect="1" noChangeArrowheads="1"/>
              </p:cNvPicPr>
              <p:nvPr/>
            </p:nvPicPr>
            <p:blipFill rotWithShape="1">
              <a:blip r:embed="rId5" cstate="print"/>
              <a:srcRect r="67674" b="57486"/>
              <a:stretch/>
            </p:blipFill>
            <p:spPr bwMode="auto">
              <a:xfrm>
                <a:off x="3458756" y="328070"/>
                <a:ext cx="2388793" cy="15066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4097627" y="-23159"/>
                <a:ext cx="122829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 smtClean="0">
                    <a:latin typeface="Arial" pitchFamily="34" charset="0"/>
                    <a:cs typeface="Arial" pitchFamily="34" charset="0"/>
                  </a:rPr>
                  <a:t>WNK2</a:t>
                </a:r>
                <a:endParaRPr lang="en-GB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5799827" y="1003721"/>
                <a:ext cx="7915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b="1" dirty="0" smtClean="0"/>
                  <a:t>Sample P1.L</a:t>
                </a:r>
                <a:endParaRPr lang="en-GB" sz="900" dirty="0" smtClean="0"/>
              </a:p>
              <a:p>
                <a:r>
                  <a:rPr lang="en-GB" sz="900" dirty="0" smtClean="0"/>
                  <a:t>MI = 51.3%</a:t>
                </a:r>
                <a:endParaRPr lang="en-GB" sz="900" dirty="0"/>
              </a:p>
            </p:txBody>
          </p:sp>
        </p:grpSp>
        <p:sp>
          <p:nvSpPr>
            <p:cNvPr id="60" name="Rectangle 59"/>
            <p:cNvSpPr/>
            <p:nvPr/>
          </p:nvSpPr>
          <p:spPr>
            <a:xfrm>
              <a:off x="6522605" y="1744517"/>
              <a:ext cx="363948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l-GR" sz="800" dirty="0" smtClean="0"/>
                <a:t>β</a:t>
              </a:r>
              <a:r>
                <a:rPr lang="en-GB" sz="800" dirty="0" smtClean="0"/>
                <a:t>-values =0.52/0.65/0.47/0.59/0.58/0.67/0.54/0.45/0.46/0.30/0.44 </a:t>
              </a:r>
              <a:endParaRPr lang="en-GB" sz="800" dirty="0"/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95</TotalTime>
  <Words>265</Words>
  <Application>Microsoft Macintosh PowerPoint</Application>
  <PresentationFormat>A4 Paper (210x297 mm)</PresentationFormat>
  <Paragraphs>4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CTORIA</dc:creator>
  <cp:lastModifiedBy>Farida Latif</cp:lastModifiedBy>
  <cp:revision>22</cp:revision>
  <cp:lastPrinted>2014-06-09T09:36:39Z</cp:lastPrinted>
  <dcterms:created xsi:type="dcterms:W3CDTF">2011-10-21T12:23:57Z</dcterms:created>
  <dcterms:modified xsi:type="dcterms:W3CDTF">2014-07-10T12:29:09Z</dcterms:modified>
</cp:coreProperties>
</file>